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3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60" r:id="rId2"/>
    <p:sldId id="361" r:id="rId3"/>
    <p:sldId id="362" r:id="rId4"/>
    <p:sldId id="359" r:id="rId5"/>
    <p:sldId id="360" r:id="rId6"/>
    <p:sldId id="366" r:id="rId7"/>
    <p:sldId id="367" r:id="rId8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7DABD224-6E36-4AAC-AB7A-0270A9C9A88C}">
          <p14:sldIdLst>
            <p14:sldId id="260"/>
            <p14:sldId id="361"/>
            <p14:sldId id="362"/>
            <p14:sldId id="359"/>
            <p14:sldId id="360"/>
            <p14:sldId id="366"/>
            <p14:sldId id="367"/>
          </p14:sldIdLst>
        </p14:section>
      </p14:sectionLst>
    </p:ext>
    <p:ext uri="{EFAFB233-063F-42B5-8137-9DF3F51BA10A}">
      <p15:sldGuideLst xmlns:p15="http://schemas.microsoft.com/office/powerpoint/2012/main">
        <p15:guide id="2" pos="2784" userDrawn="1">
          <p15:clr>
            <a:srgbClr val="A4A3A4"/>
          </p15:clr>
        </p15:guide>
        <p15:guide id="3" orient="horz" pos="22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205" autoAdjust="0"/>
    <p:restoredTop sz="96866" autoAdjust="0"/>
  </p:normalViewPr>
  <p:slideViewPr>
    <p:cSldViewPr>
      <p:cViewPr varScale="1">
        <p:scale>
          <a:sx n="130" d="100"/>
          <a:sy n="130" d="100"/>
        </p:scale>
        <p:origin x="360" y="120"/>
      </p:cViewPr>
      <p:guideLst>
        <p:guide pos="2784"/>
        <p:guide orient="horz" pos="225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oy6\Desktop\CYE%20Projects%20(2015-2016)\5)HIV-Rat%20study\1)Neurodegeneration\2)Data%20analysis\1)Animal%20data\Cho%20YE-HIV-1%20Tg%20rats%20weight-0112-201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oy6\Desktop\Copy%20of%20raw%20data%20(IHC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oy6\Desktop\Copy%20of%20raw%20data%20(IHC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oy6\Desktop\Western-blot%20density%2011042015%20by%20CY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oy6\Desktop\CYE%20Projects%20(2015-2016)\5)HIV-Rat%20study\1)Neurodegeneration\2)Data%20analysis\5)Western-blot\Western-blot%20density110216%20(Recovered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319772528433942E-2"/>
          <c:y val="0.14814814814814814"/>
          <c:w val="0.79867878833986328"/>
          <c:h val="0.7297244094488188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BE4-4B78-8E6D-F95C0C96E931}"/>
              </c:ext>
            </c:extLst>
          </c:dPt>
          <c:errBars>
            <c:errBarType val="plus"/>
            <c:errValType val="cust"/>
            <c:noEndCap val="0"/>
            <c:plus>
              <c:numRef>
                <c:f>'Male-5 months'!$B$9:$C$9</c:f>
                <c:numCache>
                  <c:formatCode>General</c:formatCode>
                  <c:ptCount val="2"/>
                  <c:pt idx="0">
                    <c:v>30.005555041247501</c:v>
                  </c:pt>
                  <c:pt idx="1">
                    <c:v>2.0615528128088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ale-5 months'!$B$3:$C$3</c:f>
              <c:strCache>
                <c:ptCount val="2"/>
                <c:pt idx="0">
                  <c:v>WT</c:v>
                </c:pt>
                <c:pt idx="1">
                  <c:v>HIV</c:v>
                </c:pt>
              </c:strCache>
            </c:strRef>
          </c:cat>
          <c:val>
            <c:numRef>
              <c:f>'Male-5 months'!$B$8:$C$8</c:f>
              <c:numCache>
                <c:formatCode>0</c:formatCode>
                <c:ptCount val="2"/>
                <c:pt idx="0">
                  <c:v>387.5</c:v>
                </c:pt>
                <c:pt idx="1">
                  <c:v>319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E4-4B78-8E6D-F95C0C96E9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05754408"/>
        <c:axId val="205754800"/>
      </c:barChart>
      <c:catAx>
        <c:axId val="205754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754800"/>
        <c:crossesAt val="0"/>
        <c:auto val="1"/>
        <c:lblAlgn val="ctr"/>
        <c:lblOffset val="100"/>
        <c:noMultiLvlLbl val="0"/>
      </c:catAx>
      <c:valAx>
        <c:axId val="205754800"/>
        <c:scaling>
          <c:orientation val="minMax"/>
          <c:max val="500"/>
          <c:min val="200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754408"/>
        <c:crosses val="autoZero"/>
        <c:crossBetween val="between"/>
        <c:majorUnit val="100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FAP (CYE)'!$L$8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FAP (CYE)'!$M$10:$P$10</c:f>
                <c:numCache>
                  <c:formatCode>General</c:formatCode>
                  <c:ptCount val="4"/>
                  <c:pt idx="0">
                    <c:v>3330</c:v>
                  </c:pt>
                  <c:pt idx="1">
                    <c:v>5965</c:v>
                  </c:pt>
                  <c:pt idx="2">
                    <c:v>3200</c:v>
                  </c:pt>
                  <c:pt idx="3">
                    <c:v>333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GFAP (CYE)'!$M$7:$O$7</c:f>
              <c:strCache>
                <c:ptCount val="3"/>
                <c:pt idx="0">
                  <c:v>Cortex</c:v>
                </c:pt>
                <c:pt idx="1">
                  <c:v>CA1</c:v>
                </c:pt>
                <c:pt idx="2">
                  <c:v>DG</c:v>
                </c:pt>
              </c:strCache>
            </c:strRef>
          </c:cat>
          <c:val>
            <c:numRef>
              <c:f>'GFAP (CYE)'!$M$8:$O$8</c:f>
              <c:numCache>
                <c:formatCode>0</c:formatCode>
                <c:ptCount val="3"/>
                <c:pt idx="0">
                  <c:v>15416.666666666668</c:v>
                </c:pt>
                <c:pt idx="1">
                  <c:v>29305.555555555558</c:v>
                </c:pt>
                <c:pt idx="2" formatCode="0.0">
                  <c:v>23958.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27-4DDD-B52B-9AFF65294D0A}"/>
            </c:ext>
          </c:extLst>
        </c:ser>
        <c:ser>
          <c:idx val="1"/>
          <c:order val="1"/>
          <c:tx>
            <c:strRef>
              <c:f>'GFAP (CYE)'!$L$9</c:f>
              <c:strCache>
                <c:ptCount val="1"/>
                <c:pt idx="0">
                  <c:v>HIV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FAP (CYE)'!$M$11:$O$11</c:f>
                <c:numCache>
                  <c:formatCode>General</c:formatCode>
                  <c:ptCount val="3"/>
                  <c:pt idx="0">
                    <c:v>11542</c:v>
                  </c:pt>
                  <c:pt idx="1">
                    <c:v>4069</c:v>
                  </c:pt>
                  <c:pt idx="2">
                    <c:v>72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GFAP (CYE)'!$M$7:$O$7</c:f>
              <c:strCache>
                <c:ptCount val="3"/>
                <c:pt idx="0">
                  <c:v>Cortex</c:v>
                </c:pt>
                <c:pt idx="1">
                  <c:v>CA1</c:v>
                </c:pt>
                <c:pt idx="2">
                  <c:v>DG</c:v>
                </c:pt>
              </c:strCache>
            </c:strRef>
          </c:cat>
          <c:val>
            <c:numRef>
              <c:f>'GFAP (CYE)'!$M$9:$O$9</c:f>
              <c:numCache>
                <c:formatCode>0</c:formatCode>
                <c:ptCount val="3"/>
                <c:pt idx="0">
                  <c:v>55856.481481481482</c:v>
                </c:pt>
                <c:pt idx="1">
                  <c:v>61875.000000000007</c:v>
                </c:pt>
                <c:pt idx="2" formatCode="0.0">
                  <c:v>48171.2962962963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D27-4DDD-B52B-9AFF65294D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205755192"/>
        <c:axId val="205755584"/>
      </c:barChart>
      <c:catAx>
        <c:axId val="205755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755584"/>
        <c:crosses val="autoZero"/>
        <c:auto val="1"/>
        <c:lblAlgn val="ctr"/>
        <c:lblOffset val="100"/>
        <c:noMultiLvlLbl val="0"/>
      </c:catAx>
      <c:valAx>
        <c:axId val="205755584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7551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3400704137401942"/>
          <c:y val="8.0781683785589808E-2"/>
          <c:w val="0.32025465509756235"/>
          <c:h val="0.110353331817774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euN (CYE) '!$L$8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euN (CYE) '!$M$10:$P$10</c:f>
                <c:numCache>
                  <c:formatCode>General</c:formatCode>
                  <c:ptCount val="4"/>
                  <c:pt idx="0">
                    <c:v>55880.614685623113</c:v>
                  </c:pt>
                  <c:pt idx="1">
                    <c:v>5965</c:v>
                  </c:pt>
                  <c:pt idx="2">
                    <c:v>23983.983853427544</c:v>
                  </c:pt>
                  <c:pt idx="3">
                    <c:v>9664.51125395271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euN (CYE) '!$M$7:$O$7</c:f>
              <c:strCache>
                <c:ptCount val="3"/>
                <c:pt idx="0">
                  <c:v>Cortex</c:v>
                </c:pt>
                <c:pt idx="1">
                  <c:v>CA1</c:v>
                </c:pt>
                <c:pt idx="2">
                  <c:v>DG</c:v>
                </c:pt>
              </c:strCache>
            </c:strRef>
          </c:cat>
          <c:val>
            <c:numRef>
              <c:f>'NeuN (CYE) '!$M$8:$O$8</c:f>
              <c:numCache>
                <c:formatCode>0</c:formatCode>
                <c:ptCount val="3"/>
                <c:pt idx="0" formatCode="General">
                  <c:v>250555.55555555559</c:v>
                </c:pt>
                <c:pt idx="1">
                  <c:v>73333</c:v>
                </c:pt>
                <c:pt idx="2" formatCode="General">
                  <c:v>186666.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C0-466F-80DD-067778B4C783}"/>
            </c:ext>
          </c:extLst>
        </c:ser>
        <c:ser>
          <c:idx val="1"/>
          <c:order val="1"/>
          <c:tx>
            <c:strRef>
              <c:f>'NeuN (CYE) '!$L$9</c:f>
              <c:strCache>
                <c:ptCount val="1"/>
                <c:pt idx="0">
                  <c:v>HIV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euN (CYE) '!$M$11:$O$11</c:f>
                <c:numCache>
                  <c:formatCode>General</c:formatCode>
                  <c:ptCount val="3"/>
                  <c:pt idx="0">
                    <c:v>12906.683988635183</c:v>
                  </c:pt>
                  <c:pt idx="1">
                    <c:v>4069</c:v>
                  </c:pt>
                  <c:pt idx="2">
                    <c:v>16501.0712844759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euN (CYE) '!$M$7:$O$7</c:f>
              <c:strCache>
                <c:ptCount val="3"/>
                <c:pt idx="0">
                  <c:v>Cortex</c:v>
                </c:pt>
                <c:pt idx="1">
                  <c:v>CA1</c:v>
                </c:pt>
                <c:pt idx="2">
                  <c:v>DG</c:v>
                </c:pt>
              </c:strCache>
            </c:strRef>
          </c:cat>
          <c:val>
            <c:numRef>
              <c:f>'NeuN (CYE) '!$M$9:$O$9</c:f>
              <c:numCache>
                <c:formatCode>0</c:formatCode>
                <c:ptCount val="3"/>
                <c:pt idx="0" formatCode="General">
                  <c:v>93888.888888888891</c:v>
                </c:pt>
                <c:pt idx="1">
                  <c:v>52314</c:v>
                </c:pt>
                <c:pt idx="2" formatCode="General">
                  <c:v>120416.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C0-466F-80DD-067778B4C7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205756368"/>
        <c:axId val="206268152"/>
      </c:barChart>
      <c:catAx>
        <c:axId val="205756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68152"/>
        <c:crosses val="autoZero"/>
        <c:auto val="1"/>
        <c:lblAlgn val="ctr"/>
        <c:lblOffset val="100"/>
        <c:noMultiLvlLbl val="0"/>
      </c:catAx>
      <c:valAx>
        <c:axId val="206268152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7563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6676359179275071"/>
          <c:y val="0.166493261449841"/>
          <c:w val="0.31413434757973735"/>
          <c:h val="8.41065179352580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319772528433942E-2"/>
          <c:y val="0.14814814814814814"/>
          <c:w val="0.82330745643676939"/>
          <c:h val="0.729724409448818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u N'!$I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eu N'!$I$7:$I$8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eu N'!$H$5:$H$6</c:f>
              <c:strCache>
                <c:ptCount val="2"/>
                <c:pt idx="0">
                  <c:v>NeuN</c:v>
                </c:pt>
                <c:pt idx="1">
                  <c:v>GFAP</c:v>
                </c:pt>
              </c:strCache>
            </c:strRef>
          </c:cat>
          <c:val>
            <c:numRef>
              <c:f>'Neu N'!$I$5:$I$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BF-4D55-BB50-B9A68022537F}"/>
            </c:ext>
          </c:extLst>
        </c:ser>
        <c:ser>
          <c:idx val="1"/>
          <c:order val="1"/>
          <c:tx>
            <c:strRef>
              <c:f>'Neu N'!$J$4</c:f>
              <c:strCache>
                <c:ptCount val="1"/>
                <c:pt idx="0">
                  <c:v>HIV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eu N'!$J$7:$J$8</c:f>
                <c:numCache>
                  <c:formatCode>General</c:formatCode>
                  <c:ptCount val="2"/>
                  <c:pt idx="0">
                    <c:v>0.28000000000000003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eu N'!$H$5:$H$6</c:f>
              <c:strCache>
                <c:ptCount val="2"/>
                <c:pt idx="0">
                  <c:v>NeuN</c:v>
                </c:pt>
                <c:pt idx="1">
                  <c:v>GFAP</c:v>
                </c:pt>
              </c:strCache>
            </c:strRef>
          </c:cat>
          <c:val>
            <c:numRef>
              <c:f>'Neu N'!$J$5:$J$6</c:f>
              <c:numCache>
                <c:formatCode>General</c:formatCode>
                <c:ptCount val="2"/>
                <c:pt idx="0">
                  <c:v>0.3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BF-4D55-BB50-B9A6802253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06268936"/>
        <c:axId val="206269328"/>
      </c:barChart>
      <c:catAx>
        <c:axId val="206268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69328"/>
        <c:crossesAt val="0"/>
        <c:auto val="1"/>
        <c:lblAlgn val="ctr"/>
        <c:lblOffset val="100"/>
        <c:noMultiLvlLbl val="0"/>
      </c:catAx>
      <c:valAx>
        <c:axId val="206269328"/>
        <c:scaling>
          <c:orientation val="minMax"/>
          <c:max val="4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68936"/>
        <c:crosses val="autoZero"/>
        <c:crossBetween val="between"/>
        <c:majorUnit val="1"/>
        <c:minorUnit val="0.5"/>
      </c:valAx>
      <c:spPr>
        <a:noFill/>
        <a:ln>
          <a:noFill/>
        </a:ln>
        <a:effectLst/>
      </c:spPr>
    </c:plotArea>
    <c:legend>
      <c:legendPos val="t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27536732604457637"/>
          <c:y val="5.1795219240088682E-2"/>
          <c:w val="0.34288375616887917"/>
          <c:h val="0.18731720646359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319772528433942E-2"/>
          <c:y val="0.14814814814814814"/>
          <c:w val="0.82330745643676939"/>
          <c:h val="0.729724409448818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myloid!$O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myloid!$O$7:$P$7</c:f>
                <c:numCache>
                  <c:formatCode>General</c:formatCode>
                  <c:ptCount val="2"/>
                  <c:pt idx="0">
                    <c:v>0.79</c:v>
                  </c:pt>
                  <c:pt idx="1">
                    <c:v>0.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myloid!$N$5:$N$6</c:f>
              <c:strCache>
                <c:ptCount val="2"/>
                <c:pt idx="0">
                  <c:v>NeuN</c:v>
                </c:pt>
                <c:pt idx="1">
                  <c:v>GFAP</c:v>
                </c:pt>
              </c:strCache>
            </c:strRef>
          </c:cat>
          <c:val>
            <c:numRef>
              <c:f>amyloid!$O$5:$O$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72-47CD-AC59-A29A9CF2F050}"/>
            </c:ext>
          </c:extLst>
        </c:ser>
        <c:ser>
          <c:idx val="1"/>
          <c:order val="1"/>
          <c:tx>
            <c:strRef>
              <c:f>amyloid!$P$4</c:f>
              <c:strCache>
                <c:ptCount val="1"/>
                <c:pt idx="0">
                  <c:v>HIV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myloid!$O$8:$P$8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myloid!$N$5:$N$6</c:f>
              <c:strCache>
                <c:ptCount val="2"/>
                <c:pt idx="0">
                  <c:v>NeuN</c:v>
                </c:pt>
                <c:pt idx="1">
                  <c:v>GFAP</c:v>
                </c:pt>
              </c:strCache>
            </c:strRef>
          </c:cat>
          <c:val>
            <c:numRef>
              <c:f>amyloid!$P$5:$P$6</c:f>
              <c:numCache>
                <c:formatCode>General</c:formatCode>
                <c:ptCount val="2"/>
                <c:pt idx="0">
                  <c:v>0.4</c:v>
                </c:pt>
                <c:pt idx="1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72-47CD-AC59-A29A9CF2F0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06270112"/>
        <c:axId val="206270504"/>
      </c:barChart>
      <c:catAx>
        <c:axId val="206270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70504"/>
        <c:crossesAt val="0"/>
        <c:auto val="1"/>
        <c:lblAlgn val="ctr"/>
        <c:lblOffset val="100"/>
        <c:noMultiLvlLbl val="0"/>
      </c:catAx>
      <c:valAx>
        <c:axId val="206270504"/>
        <c:scaling>
          <c:orientation val="minMax"/>
          <c:max val="4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70112"/>
        <c:crosses val="autoZero"/>
        <c:crossBetween val="between"/>
        <c:majorUnit val="1"/>
        <c:min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5446375783374714"/>
          <c:y val="5.2006595756904424E-2"/>
          <c:w val="0.27301530222997561"/>
          <c:h val="0.182330245435935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D9A0BB-27D5-40A4-AD7E-1FD93841160D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B61757-3D12-46AD-B7C9-53165997A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57249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2EE4ED1-CE09-4B19-A6E9-6E5DDF9CD3D9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181468C-6CCF-4195-9076-2E1206A76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6839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solidFill>
                  <a:srgbClr val="FF0000"/>
                </a:solidFill>
              </a:rPr>
              <a:t>Please change n=4 to n=8, if you have the record of body weights of the next 4 rats.</a:t>
            </a:r>
          </a:p>
          <a:p>
            <a:endParaRPr lang="en-US" dirty="0">
              <a:solidFill>
                <a:srgbClr val="FF0000"/>
              </a:solidFill>
            </a:endParaRPr>
          </a:p>
          <a:p>
            <a:r>
              <a:rPr lang="en-US" dirty="0">
                <a:solidFill>
                  <a:srgbClr val="FF0000"/>
                </a:solidFill>
              </a:rPr>
              <a:t>Yes,</a:t>
            </a:r>
            <a:r>
              <a:rPr lang="en-US" baseline="0" dirty="0">
                <a:solidFill>
                  <a:srgbClr val="FF0000"/>
                </a:solidFill>
              </a:rPr>
              <a:t> I changed it.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81468C-6CCF-4195-9076-2E1206A76B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200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81468C-6CCF-4195-9076-2E1206A76B6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447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81468C-6CCF-4195-9076-2E1206A76B6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8030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81468C-6CCF-4195-9076-2E1206A76B6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88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57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239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290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824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173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657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585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152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177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58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0D1B5-FE5F-404A-AAA6-6F914D493346}" type="datetimeFigureOut">
              <a:rPr lang="en-US" smtClean="0"/>
              <a:t>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B2AE7-31D5-4554-8A00-3310CEE707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134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chart" Target="../charts/chart5.xml"/><Relationship Id="rId4" Type="http://schemas.openxmlformats.org/officeDocument/2006/relationships/image" Target="../media/image10.png"/><Relationship Id="rId9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A in S1 File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286001" y="1322112"/>
            <a:ext cx="3276599" cy="2531879"/>
            <a:chOff x="2286001" y="1322112"/>
            <a:chExt cx="3276599" cy="2531879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59198484"/>
                </p:ext>
              </p:extLst>
            </p:nvPr>
          </p:nvGraphicFramePr>
          <p:xfrm>
            <a:off x="2743200" y="1322112"/>
            <a:ext cx="2819400" cy="25318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1504964" y="2480904"/>
              <a:ext cx="19006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Body weight (g)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962401" y="1485338"/>
              <a:ext cx="10534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=</a:t>
              </a:r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group</a:t>
              </a:r>
            </a:p>
          </p:txBody>
        </p:sp>
        <p:sp>
          <p:nvSpPr>
            <p:cNvPr id="16" name="직사각형 14"/>
            <p:cNvSpPr/>
            <p:nvPr/>
          </p:nvSpPr>
          <p:spPr>
            <a:xfrm>
              <a:off x="4695877" y="2419350"/>
              <a:ext cx="304892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2400" b="1" dirty="0">
                  <a:latin typeface="Arial" pitchFamily="34" charset="0"/>
                  <a:cs typeface="Arial" pitchFamily="34" charset="0"/>
                </a:rPr>
                <a:t>*</a:t>
              </a:r>
              <a:endParaRPr lang="ko-KR" altLang="en-US" sz="2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" name="Rectangle 7"/>
          <p:cNvSpPr/>
          <p:nvPr/>
        </p:nvSpPr>
        <p:spPr>
          <a:xfrm>
            <a:off x="1447800" y="4097621"/>
            <a:ext cx="65532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A in S1 file. Comparison of the body weight in 5-month old WT and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 rats.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 Relative body weight of WT and HIV-1 Tg rats (n=8/group)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229382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8193" r="17900"/>
          <a:stretch/>
        </p:blipFill>
        <p:spPr>
          <a:xfrm rot="5400000">
            <a:off x="470217" y="2159499"/>
            <a:ext cx="1928124" cy="25908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t="6250" b="40173"/>
          <a:stretch/>
        </p:blipFill>
        <p:spPr>
          <a:xfrm>
            <a:off x="4545471" y="2490836"/>
            <a:ext cx="2762852" cy="192812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73493" y="2157939"/>
            <a:ext cx="16520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21026" y="2152368"/>
            <a:ext cx="1637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HIV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11573" y="762000"/>
            <a:ext cx="2267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GFAP IHC staining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384638" y="1577790"/>
            <a:ext cx="1637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HIV</a:t>
            </a:r>
          </a:p>
        </p:txBody>
      </p:sp>
      <p:pic>
        <p:nvPicPr>
          <p:cNvPr id="22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1399" y="1923903"/>
            <a:ext cx="1630435" cy="1133867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/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6"/>
          <a:srcRect l="7226" r="6591" b="13131"/>
          <a:stretch/>
        </p:blipFill>
        <p:spPr>
          <a:xfrm>
            <a:off x="7384638" y="4325887"/>
            <a:ext cx="1637195" cy="1160513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91400" y="3101067"/>
            <a:ext cx="1630434" cy="1150893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7148889" y="1923903"/>
            <a:ext cx="1080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142127" y="3098765"/>
            <a:ext cx="921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150960" y="4320267"/>
            <a:ext cx="82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</a:p>
        </p:txBody>
      </p:sp>
      <p:pic>
        <p:nvPicPr>
          <p:cNvPr id="28" name="Picture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2801" y="1923902"/>
            <a:ext cx="1672402" cy="11031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/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09720" y="3067248"/>
            <a:ext cx="1645483" cy="1161579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10"/>
          <a:srcRect l="7383"/>
          <a:stretch/>
        </p:blipFill>
        <p:spPr>
          <a:xfrm>
            <a:off x="2809721" y="4302754"/>
            <a:ext cx="1645482" cy="1183646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2597562" y="1927587"/>
            <a:ext cx="1080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590800" y="3102449"/>
            <a:ext cx="921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599633" y="4323951"/>
            <a:ext cx="82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744701" y="1554955"/>
            <a:ext cx="1637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WT</a:t>
            </a:r>
          </a:p>
        </p:txBody>
      </p:sp>
      <p:sp>
        <p:nvSpPr>
          <p:cNvPr id="3" name="Rectangle 2"/>
          <p:cNvSpPr/>
          <p:nvPr/>
        </p:nvSpPr>
        <p:spPr>
          <a:xfrm>
            <a:off x="6004560" y="3337560"/>
            <a:ext cx="179022" cy="14362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394015" y="3437779"/>
            <a:ext cx="179022" cy="14362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984107" y="3545540"/>
            <a:ext cx="629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626894" y="3446925"/>
            <a:ext cx="629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</a:p>
        </p:txBody>
      </p:sp>
      <p:sp>
        <p:nvSpPr>
          <p:cNvPr id="39" name="Rectangle 38"/>
          <p:cNvSpPr/>
          <p:nvPr/>
        </p:nvSpPr>
        <p:spPr>
          <a:xfrm>
            <a:off x="1649237" y="3331124"/>
            <a:ext cx="152400" cy="14478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6241638" y="3193742"/>
            <a:ext cx="152400" cy="14478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1675259" y="3342924"/>
            <a:ext cx="629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275624" y="3173505"/>
            <a:ext cx="629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</a:p>
        </p:txBody>
      </p:sp>
      <p:sp>
        <p:nvSpPr>
          <p:cNvPr id="44" name="Rectangle 43"/>
          <p:cNvSpPr/>
          <p:nvPr/>
        </p:nvSpPr>
        <p:spPr>
          <a:xfrm>
            <a:off x="6553200" y="3505200"/>
            <a:ext cx="152400" cy="14478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1912368" y="3666565"/>
            <a:ext cx="152400" cy="14478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6227612" y="3619452"/>
            <a:ext cx="108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660439" y="3759851"/>
            <a:ext cx="108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4718377" y="4327599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31909" y="4252086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429909" y="5687168"/>
            <a:ext cx="825689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B in S1 file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IHC staining for GFAP in the cerebral cortex, hippocampal CA1 region and dentate gyrus (DG) of the WT and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s. 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48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B in S1 File</a:t>
            </a:r>
          </a:p>
        </p:txBody>
      </p:sp>
    </p:spTree>
    <p:extLst>
      <p:ext uri="{BB962C8B-B14F-4D97-AF65-F5344CB8AC3E}">
        <p14:creationId xmlns:p14="http://schemas.microsoft.com/office/powerpoint/2010/main" val="3089065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971537" y="2497723"/>
            <a:ext cx="2891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NeuN+ cells/mm</a:t>
            </a:r>
            <a:r>
              <a:rPr lang="en-US" altLang="ko-KR" sz="1600" b="1" baseline="30000" dirty="0">
                <a:latin typeface="Arial" pitchFamily="34" charset="0"/>
                <a:cs typeface="Arial" pitchFamily="34" charset="0"/>
              </a:rPr>
              <a:t>3</a:t>
            </a:r>
            <a:endParaRPr lang="ko-KR" altLang="en-US" sz="1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3674477" y="2425333"/>
            <a:ext cx="2590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GFAP+ cells/mm</a:t>
            </a:r>
            <a:r>
              <a:rPr lang="en-US" altLang="ko-KR" sz="1600" b="1" baseline="30000" dirty="0">
                <a:latin typeface="Arial" pitchFamily="34" charset="0"/>
                <a:cs typeface="Arial" pitchFamily="34" charset="0"/>
              </a:rPr>
              <a:t>3</a:t>
            </a:r>
            <a:endParaRPr lang="ko-KR" altLang="en-US" sz="1600" b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8691230"/>
              </p:ext>
            </p:extLst>
          </p:nvPr>
        </p:nvGraphicFramePr>
        <p:xfrm>
          <a:off x="5139155" y="1143000"/>
          <a:ext cx="3700045" cy="2903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5786142"/>
              </p:ext>
            </p:extLst>
          </p:nvPr>
        </p:nvGraphicFramePr>
        <p:xfrm>
          <a:off x="643355" y="1267641"/>
          <a:ext cx="3808438" cy="28449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직사각형 14"/>
          <p:cNvSpPr/>
          <p:nvPr/>
        </p:nvSpPr>
        <p:spPr>
          <a:xfrm>
            <a:off x="1981200" y="2831068"/>
            <a:ext cx="4094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직사각형 14"/>
          <p:cNvSpPr/>
          <p:nvPr/>
        </p:nvSpPr>
        <p:spPr>
          <a:xfrm>
            <a:off x="6375011" y="1653990"/>
            <a:ext cx="4094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14"/>
          <p:cNvSpPr/>
          <p:nvPr/>
        </p:nvSpPr>
        <p:spPr>
          <a:xfrm>
            <a:off x="8230201" y="1963039"/>
            <a:ext cx="4094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직사각형 14"/>
          <p:cNvSpPr/>
          <p:nvPr/>
        </p:nvSpPr>
        <p:spPr>
          <a:xfrm>
            <a:off x="7295347" y="1703295"/>
            <a:ext cx="4094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43355" y="4401001"/>
            <a:ext cx="789104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C in S1 file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Summary of the number of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euN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positive or GFAP-positive cells in the cerebral cortex, hippocampal CA1 region and dentate gyrus (DG) of the WT and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s. *</a:t>
            </a:r>
            <a:r>
              <a:rPr lang="en-US" sz="1400" i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&lt; 0.05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C in S1 File</a:t>
            </a:r>
          </a:p>
        </p:txBody>
      </p:sp>
    </p:spTree>
    <p:extLst>
      <p:ext uri="{BB962C8B-B14F-4D97-AF65-F5344CB8AC3E}">
        <p14:creationId xmlns:p14="http://schemas.microsoft.com/office/powerpoint/2010/main" val="4110590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2035" y="1402045"/>
            <a:ext cx="1900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n1     n2     n3     n4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90600" y="1087398"/>
            <a:ext cx="1592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83064" y="1087398"/>
            <a:ext cx="1563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36774" y="1396129"/>
            <a:ext cx="188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n1     n2     n3     n4 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2622883" y="1384554"/>
            <a:ext cx="15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982864" y="1400631"/>
            <a:ext cx="15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6779" y="2129514"/>
            <a:ext cx="3268009" cy="37427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066804" y="1676178"/>
            <a:ext cx="857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99055" y="2606314"/>
            <a:ext cx="857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6779" y="2561549"/>
            <a:ext cx="3268009" cy="39943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6778" y="1665584"/>
            <a:ext cx="3268009" cy="381659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195658" y="2120713"/>
            <a:ext cx="857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6677" y="1603798"/>
            <a:ext cx="39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39880" y="1827738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4148" y="1385420"/>
            <a:ext cx="513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5073" y="2610300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4235825" y="2270176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50898" y="2053741"/>
            <a:ext cx="4506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48767" y="2276327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90316" y="2147036"/>
            <a:ext cx="3235927" cy="383224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4831395" y="1406107"/>
            <a:ext cx="1900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n5     n6     n7     n8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169960" y="1091460"/>
            <a:ext cx="1592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762424" y="1091460"/>
            <a:ext cx="1563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716134" y="1400191"/>
            <a:ext cx="188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n5    n6     n7     n8 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6802243" y="1409397"/>
            <a:ext cx="15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5162224" y="1404693"/>
            <a:ext cx="15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326904" y="1417190"/>
            <a:ext cx="513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8346754" y="1766854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8346754" y="1999994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8394544" y="1629391"/>
            <a:ext cx="39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437746" y="1898156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8348022" y="2205343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8348022" y="2438483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8348765" y="2079334"/>
            <a:ext cx="4506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8446634" y="2301920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7"/>
          <a:srcRect b="22374"/>
          <a:stretch/>
        </p:blipFill>
        <p:spPr>
          <a:xfrm flipH="1">
            <a:off x="5090316" y="1677191"/>
            <a:ext cx="3235926" cy="400272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6400800" y="769263"/>
            <a:ext cx="938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et II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153584" y="779045"/>
            <a:ext cx="938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et I</a:t>
            </a:r>
          </a:p>
        </p:txBody>
      </p:sp>
      <p:cxnSp>
        <p:nvCxnSpPr>
          <p:cNvPr id="48" name="Straight Connector 47"/>
          <p:cNvCxnSpPr/>
          <p:nvPr/>
        </p:nvCxnSpPr>
        <p:spPr>
          <a:xfrm>
            <a:off x="8354130" y="2771418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8459048" y="2641714"/>
            <a:ext cx="3562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90316" y="2568193"/>
            <a:ext cx="3235926" cy="381000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-67734" y="3922299"/>
            <a:ext cx="203446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</a:p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1" name="Chart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3778443"/>
              </p:ext>
            </p:extLst>
          </p:nvPr>
        </p:nvGraphicFramePr>
        <p:xfrm>
          <a:off x="1411100" y="3141692"/>
          <a:ext cx="2761239" cy="1961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2" name="직사각형 14"/>
          <p:cNvSpPr/>
          <p:nvPr/>
        </p:nvSpPr>
        <p:spPr>
          <a:xfrm>
            <a:off x="3423780" y="3468533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직사각형 14"/>
          <p:cNvSpPr/>
          <p:nvPr/>
        </p:nvSpPr>
        <p:spPr>
          <a:xfrm>
            <a:off x="2289075" y="4322136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3860619"/>
              </p:ext>
            </p:extLst>
          </p:nvPr>
        </p:nvGraphicFramePr>
        <p:xfrm>
          <a:off x="5718786" y="3141692"/>
          <a:ext cx="3086805" cy="1984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6" name="직사각형 14"/>
          <p:cNvSpPr/>
          <p:nvPr/>
        </p:nvSpPr>
        <p:spPr>
          <a:xfrm>
            <a:off x="7963836" y="3242751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직사각형 14"/>
          <p:cNvSpPr/>
          <p:nvPr/>
        </p:nvSpPr>
        <p:spPr>
          <a:xfrm>
            <a:off x="6698716" y="4392869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227405" y="3938728"/>
            <a:ext cx="203446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</a:p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744063" y="1741823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744063" y="1974963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745331" y="2740566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745331" y="2180312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745331" y="2413452"/>
            <a:ext cx="13320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4223643" y="2754271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4958752" y="2763236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4912660" y="2261206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4253753" y="1830912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4927373" y="1821942"/>
            <a:ext cx="74932" cy="5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652035" y="5323567"/>
            <a:ext cx="782792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D in S1 file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creased apoptosis of neuronal cells in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s.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Left) Representative immunoblots of hippocampal lysates from WT and HIV-1 </a:t>
            </a:r>
            <a:r>
              <a:rPr lang="en-US" sz="1400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s with the respective antibody to </a:t>
            </a:r>
            <a:r>
              <a:rPr lang="en-US" sz="1400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euN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GFAP, or GAPDH, used as a loading control, as indicated. (Right) Similar immunoblot results were observed with another set (n=4/group). </a:t>
            </a:r>
            <a:r>
              <a:rPr lang="en-US" sz="1400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nsitometric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alysis summary of the immunoblots for </a:t>
            </a:r>
            <a:r>
              <a:rPr lang="en-US" sz="1400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euN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r GFAP relative to GAPDH is shown below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</a:t>
            </a:r>
            <a:r>
              <a:rPr lang="en-US" sz="1400" i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&lt; 0.05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4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D in S1 File</a:t>
            </a:r>
          </a:p>
        </p:txBody>
      </p:sp>
    </p:spTree>
    <p:extLst>
      <p:ext uri="{BB962C8B-B14F-4D97-AF65-F5344CB8AC3E}">
        <p14:creationId xmlns:p14="http://schemas.microsoft.com/office/powerpoint/2010/main" val="15134594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372" y="2362200"/>
            <a:ext cx="2527357" cy="1728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976377" y="3131969"/>
            <a:ext cx="205720" cy="1382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-410859" y="3057106"/>
            <a:ext cx="1697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143774" y="1969437"/>
            <a:ext cx="15367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76600" y="2362200"/>
            <a:ext cx="2527357" cy="172851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6272" y="2363574"/>
            <a:ext cx="2527357" cy="172714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152650" y="1319937"/>
            <a:ext cx="2689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Congo red staining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814800" y="3961313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34324" y="3236260"/>
            <a:ext cx="1080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3" name="Rectangle 2"/>
          <p:cNvSpPr/>
          <p:nvPr/>
        </p:nvSpPr>
        <p:spPr>
          <a:xfrm>
            <a:off x="533399" y="4805571"/>
            <a:ext cx="795022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E in S1 file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Congo red staining of β-amyloid in the cerebral cortex of the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s with different magnifications, as indicated.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1196507" y="2360243"/>
            <a:ext cx="2080093" cy="77172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4082431" y="2590800"/>
            <a:ext cx="1327769" cy="10425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23" name="Straight Connector 22"/>
          <p:cNvCxnSpPr/>
          <p:nvPr/>
        </p:nvCxnSpPr>
        <p:spPr>
          <a:xfrm flipV="1">
            <a:off x="5410200" y="2360243"/>
            <a:ext cx="546072" cy="2305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5410200" y="3631106"/>
            <a:ext cx="553776" cy="4596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1182097" y="3276146"/>
            <a:ext cx="2102665" cy="80204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E in S1 File</a:t>
            </a:r>
          </a:p>
        </p:txBody>
      </p:sp>
    </p:spTree>
    <p:extLst>
      <p:ext uri="{BB962C8B-B14F-4D97-AF65-F5344CB8AC3E}">
        <p14:creationId xmlns:p14="http://schemas.microsoft.com/office/powerpoint/2010/main" val="3845847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326638" y="2257708"/>
            <a:ext cx="132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65409" y="1141395"/>
            <a:ext cx="2744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87700" y="627132"/>
            <a:ext cx="31674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Amyloid IHC staining</a:t>
            </a:r>
          </a:p>
        </p:txBody>
      </p:sp>
      <p:sp>
        <p:nvSpPr>
          <p:cNvPr id="8" name="Rectangle 7"/>
          <p:cNvSpPr/>
          <p:nvPr/>
        </p:nvSpPr>
        <p:spPr>
          <a:xfrm>
            <a:off x="520664" y="6019800"/>
            <a:ext cx="8318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F in S1 file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IHC staining of β-amyloid in the cerebral cortex of a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 with different magnifications, as indicated.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2"/>
          <a:srcRect b="7113"/>
          <a:stretch/>
        </p:blipFill>
        <p:spPr>
          <a:xfrm>
            <a:off x="565409" y="1463466"/>
            <a:ext cx="2754865" cy="1889334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2863074" y="2304172"/>
            <a:ext cx="358120" cy="2763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7212" y="1474952"/>
            <a:ext cx="2767013" cy="1877848"/>
          </a:xfrm>
          <a:prstGeom prst="rect">
            <a:avLst/>
          </a:prstGeom>
        </p:spPr>
      </p:pic>
      <p:pic>
        <p:nvPicPr>
          <p:cNvPr id="25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6254" y="1474951"/>
            <a:ext cx="2552946" cy="18778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3" name="Straight Connector 32"/>
          <p:cNvCxnSpPr/>
          <p:nvPr/>
        </p:nvCxnSpPr>
        <p:spPr>
          <a:xfrm>
            <a:off x="630043" y="3274231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-337275" y="4537297"/>
            <a:ext cx="132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2"/>
          <a:srcRect b="7113"/>
          <a:stretch/>
        </p:blipFill>
        <p:spPr>
          <a:xfrm>
            <a:off x="554772" y="3743054"/>
            <a:ext cx="2754865" cy="1895745"/>
          </a:xfrm>
          <a:prstGeom prst="rect">
            <a:avLst/>
          </a:prstGeom>
        </p:spPr>
      </p:pic>
      <p:cxnSp>
        <p:nvCxnSpPr>
          <p:cNvPr id="46" name="Straight Connector 45"/>
          <p:cNvCxnSpPr/>
          <p:nvPr/>
        </p:nvCxnSpPr>
        <p:spPr>
          <a:xfrm>
            <a:off x="619406" y="5560231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2407379" y="4724400"/>
            <a:ext cx="358120" cy="2763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7212" y="3740209"/>
            <a:ext cx="2767013" cy="189858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86254" y="3740208"/>
            <a:ext cx="2552946" cy="189859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555702" y="3433720"/>
            <a:ext cx="2744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</a:p>
        </p:txBody>
      </p:sp>
      <p:sp>
        <p:nvSpPr>
          <p:cNvPr id="74" name="Rectangle 73"/>
          <p:cNvSpPr/>
          <p:nvPr/>
        </p:nvSpPr>
        <p:spPr>
          <a:xfrm>
            <a:off x="5769592" y="2085847"/>
            <a:ext cx="358120" cy="2763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3221194" y="1474951"/>
            <a:ext cx="186018" cy="8292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V="1">
            <a:off x="2765499" y="3740208"/>
            <a:ext cx="641713" cy="981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V="1">
            <a:off x="6127712" y="1474951"/>
            <a:ext cx="168250" cy="6108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/>
          <p:cNvSpPr/>
          <p:nvPr/>
        </p:nvSpPr>
        <p:spPr>
          <a:xfrm>
            <a:off x="3611825" y="4889345"/>
            <a:ext cx="358120" cy="2763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83" name="Straight Connector 82"/>
          <p:cNvCxnSpPr/>
          <p:nvPr/>
        </p:nvCxnSpPr>
        <p:spPr>
          <a:xfrm flipV="1">
            <a:off x="3960667" y="3740208"/>
            <a:ext cx="2335295" cy="114119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2755181" y="4990790"/>
            <a:ext cx="653284" cy="64800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969945" y="5165698"/>
            <a:ext cx="2325587" cy="4731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3221194" y="2588471"/>
            <a:ext cx="186018" cy="770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6127712" y="2350414"/>
            <a:ext cx="158542" cy="100238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F in S1 File</a:t>
            </a:r>
          </a:p>
        </p:txBody>
      </p:sp>
    </p:spTree>
    <p:extLst>
      <p:ext uri="{BB962C8B-B14F-4D97-AF65-F5344CB8AC3E}">
        <p14:creationId xmlns:p14="http://schemas.microsoft.com/office/powerpoint/2010/main" val="5449730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803" y="3810000"/>
            <a:ext cx="2526268" cy="1821121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6642" y="1519407"/>
            <a:ext cx="2526268" cy="182571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-679990" y="2202049"/>
            <a:ext cx="2182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sp>
        <p:nvSpPr>
          <p:cNvPr id="8" name="Rectangle 7"/>
          <p:cNvSpPr/>
          <p:nvPr/>
        </p:nvSpPr>
        <p:spPr>
          <a:xfrm>
            <a:off x="520664" y="6019800"/>
            <a:ext cx="831853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Figure G in S1 file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HC staining of β-amyloid in the cerebral cortex of another HIV-1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g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at with different magnifications, as indicated.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725935" y="3198031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0140" y="1526839"/>
            <a:ext cx="2720897" cy="1818279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-434730" y="4597512"/>
            <a:ext cx="1697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IV 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735921" y="5476352"/>
            <a:ext cx="283168" cy="23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2491271" y="1693676"/>
            <a:ext cx="282997" cy="1729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4615" y="3821151"/>
            <a:ext cx="2741341" cy="1809970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1187057" y="5145295"/>
            <a:ext cx="282997" cy="1729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565409" y="1189947"/>
            <a:ext cx="2744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08642" y="701702"/>
            <a:ext cx="32645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Amyloid IHC staining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09600" y="3482272"/>
            <a:ext cx="2744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view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47645" y="1519035"/>
            <a:ext cx="2797760" cy="182608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47645" y="3810000"/>
            <a:ext cx="2797760" cy="1821121"/>
          </a:xfrm>
          <a:prstGeom prst="rect">
            <a:avLst/>
          </a:prstGeom>
        </p:spPr>
      </p:pic>
      <p:cxnSp>
        <p:nvCxnSpPr>
          <p:cNvPr id="31" name="Straight Connector 30"/>
          <p:cNvCxnSpPr/>
          <p:nvPr/>
        </p:nvCxnSpPr>
        <p:spPr>
          <a:xfrm flipV="1">
            <a:off x="1465121" y="3810000"/>
            <a:ext cx="1782524" cy="13352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1465121" y="5318229"/>
            <a:ext cx="1782524" cy="31289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2774268" y="1526839"/>
            <a:ext cx="473377" cy="16271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770881" y="1858548"/>
            <a:ext cx="476764" cy="148254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4149168" y="2203172"/>
            <a:ext cx="685800" cy="463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44" name="Straight Connector 43"/>
          <p:cNvCxnSpPr/>
          <p:nvPr/>
        </p:nvCxnSpPr>
        <p:spPr>
          <a:xfrm flipV="1">
            <a:off x="4834968" y="1528501"/>
            <a:ext cx="1299647" cy="6695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4834968" y="2667000"/>
            <a:ext cx="1299647" cy="6740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3945960" y="4424924"/>
            <a:ext cx="685800" cy="463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4631760" y="3820826"/>
            <a:ext cx="1502855" cy="5981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4631760" y="4889878"/>
            <a:ext cx="1502855" cy="74124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직사각형 42"/>
          <p:cNvSpPr/>
          <p:nvPr/>
        </p:nvSpPr>
        <p:spPr>
          <a:xfrm>
            <a:off x="0" y="1524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itchFamily="34" charset="0"/>
                <a:ea typeface="Kozuka Mincho Pro H" pitchFamily="18" charset="-128"/>
                <a:cs typeface="Arial" pitchFamily="34" charset="0"/>
              </a:rPr>
              <a:t>Figure G in S1 File</a:t>
            </a:r>
          </a:p>
        </p:txBody>
      </p:sp>
    </p:spTree>
    <p:extLst>
      <p:ext uri="{BB962C8B-B14F-4D97-AF65-F5344CB8AC3E}">
        <p14:creationId xmlns:p14="http://schemas.microsoft.com/office/powerpoint/2010/main" val="2859861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13</TotalTime>
  <Words>458</Words>
  <Application>Microsoft Office PowerPoint</Application>
  <PresentationFormat>On-screen Show (4:3)</PresentationFormat>
  <Paragraphs>94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Kozuka Mincho Pro H</vt:lpstr>
      <vt:lpstr>맑은 고딕</vt:lpstr>
      <vt:lpstr>맑은 고딕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IAA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, Young Eun (NIH/NIAAA) [F]</dc:creator>
  <cp:lastModifiedBy>Song, B. J. (NIH/NIAAA) [E]</cp:lastModifiedBy>
  <cp:revision>1168</cp:revision>
  <cp:lastPrinted>2016-12-16T17:07:55Z</cp:lastPrinted>
  <dcterms:created xsi:type="dcterms:W3CDTF">2015-06-01T15:06:42Z</dcterms:created>
  <dcterms:modified xsi:type="dcterms:W3CDTF">2017-01-09T15:25:45Z</dcterms:modified>
</cp:coreProperties>
</file>